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610" y="-5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897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32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6" y="396875"/>
            <a:ext cx="4849813" cy="845185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18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613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005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97301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44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2069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919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150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633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05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DBE96-20D5-4FF3-B11B-78078E7ACCD1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E2054-7AF2-440C-ACF6-F736221CD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010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2" descr="C:\Users\owner\Desktop\学会\2013眼炎症学会\アレルギー写真\橋本\6680217_2012-12-03 R#2.jpg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04" y="1206618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5" descr="C:\Users\owner\Desktop\学会\2013眼炎症学会\アレルギー写真\橋本\6680217_2012-12-17 R#2.jpg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04" y="1986188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6" descr="C:\Users\owner\Desktop\学会\2013眼炎症学会\アレルギー写真\橋本\6680217_2013-01-07 R#2.jpg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04" y="2781007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3" name="テキスト ボックス 92"/>
          <p:cNvSpPr txBox="1"/>
          <p:nvPr/>
        </p:nvSpPr>
        <p:spPr>
          <a:xfrm>
            <a:off x="128464" y="12063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128464" y="197849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128464" y="27550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5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96" name="Picture 3" descr="C:\Users\owner\Desktop\学会\2013眼炎症学会\アレルギー写真\橋本\6680217_2012-12-03 L#2.jpg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7042" y="1206618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7" name="Picture 4" descr="C:\Users\owner\Desktop\学会\2013眼炎症学会\アレルギー写真\橋本\6680217_2012-12-17 L#2.jpg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7042" y="1986189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8" name="Picture 7" descr="C:\Users\owner\Desktop\学会\2013眼炎症学会\アレルギー写真\橋本\6680217_2013-01-07 L#2.jpg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7042" y="2781008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9" name="テキスト ボックス 98"/>
          <p:cNvSpPr txBox="1"/>
          <p:nvPr/>
        </p:nvSpPr>
        <p:spPr>
          <a:xfrm>
            <a:off x="1616802" y="12063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1616802" y="197849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616802" y="27550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5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03" name="Picture 2" descr="C:\Users\owner\Desktop\学会\2013眼炎症学会\アレルギー写真\石飛\3199523_2013-01-07 R#2.jpg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297" y="1206150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" name="Picture 5" descr="C:\Users\owner\Desktop\学会\2013眼炎症学会\アレルギー写真\石飛\3199523_2013-01-21 R#2.jpg"/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297" y="1988183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Picture 7" descr="C:\Users\owner\Desktop\学会\2013眼炎症学会\アレルギー写真\石飛\3199523_2013-02-04 R#2.jpg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297" y="2778777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6" name="テキスト ボックス 115"/>
          <p:cNvSpPr txBox="1"/>
          <p:nvPr/>
        </p:nvSpPr>
        <p:spPr>
          <a:xfrm>
            <a:off x="3296976" y="120585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3296976" y="198560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296976" y="27630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4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19" name="Picture 3" descr="C:\Users\owner\Desktop\学会\2013眼炎症学会\アレルギー写真\石飛\3199523_2013-01-07 L#2.jpg"/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9144" y="1206150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" name="Picture 4" descr="C:\Users\owner\Desktop\学会\2013眼炎症学会\アレルギー写真\石飛\3199523_2013-01-21 L#2.jpg"/>
          <p:cNvPicPr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9144" y="1993299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" name="Picture 6" descr="C:\Users\owner\Desktop\学会\2013眼炎症学会\アレルギー写真\石飛\3199523_2013-02-04 L#2.jpg"/>
          <p:cNvPicPr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9144" y="2780541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2" name="テキスト ボックス 121"/>
          <p:cNvSpPr txBox="1"/>
          <p:nvPr/>
        </p:nvSpPr>
        <p:spPr>
          <a:xfrm>
            <a:off x="4809144" y="120585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809144" y="198560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4809144" y="2763020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4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26" name="Picture 2" descr="C:\Users\owner\Desktop\学会\2013眼炎症学会\アレルギー写真\大月\6442866_2013-02-18 R#2.jpg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3586" y="1206321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7" name="Picture 5" descr="C:\Users\owner\Desktop\学会\2013眼炎症学会\アレルギー写真\大月\6442866_2013-03-04 R#2.jpg"/>
          <p:cNvPicPr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3586" y="1985914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8" name="Picture 7" descr="C:\Users\owner\Desktop\学会\2013眼炎症学会\アレルギー写真\大月\6442866_2013-03-18 R#2.jpg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3586" y="2780110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9" name="テキスト ボックス 128"/>
          <p:cNvSpPr txBox="1"/>
          <p:nvPr/>
        </p:nvSpPr>
        <p:spPr>
          <a:xfrm>
            <a:off x="6492380" y="1227059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6492380" y="195606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6492380" y="275455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4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33" name="Picture 9" descr="C:\Users\owner\Desktop\ムコスタ涙液論文\0wL 村上.jpg"/>
          <p:cNvPicPr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4278" y="1206320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4" name="Picture 11" descr="C:\Users\owner\Desktop\ムコスタ涙液論文\2wL 村上.jpg"/>
          <p:cNvPicPr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4278" y="1977602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5" name="Picture 12" descr="C:\Users\owner\Desktop\ムコスタ涙液論文\6wL 村上.jpg"/>
          <p:cNvPicPr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4278" y="2772074"/>
            <a:ext cx="1440000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6" name="テキスト ボックス 135"/>
          <p:cNvSpPr txBox="1"/>
          <p:nvPr/>
        </p:nvSpPr>
        <p:spPr>
          <a:xfrm>
            <a:off x="8160170" y="1214787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0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8160170" y="194379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8160170" y="2742281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6</a:t>
            </a:r>
            <a:r>
              <a:rPr kumimoji="1" lang="en-US" altLang="ja-JP" sz="12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AR丸ゴシック体M" panose="020B0609010101010101" pitchFamily="49" charset="-128"/>
                <a:cs typeface="Times New Roman" panose="02020603050405020304" pitchFamily="18" charset="0"/>
              </a:rPr>
              <a:t>w</a:t>
            </a:r>
            <a:endParaRPr kumimoji="1" lang="ja-JP" altLang="en-US" sz="1200" b="1" dirty="0">
              <a:solidFill>
                <a:schemeClr val="bg1"/>
              </a:solidFill>
              <a:latin typeface="Times New Roman" panose="02020603050405020304" pitchFamily="18" charset="0"/>
              <a:ea typeface="AR丸ゴシック体M" panose="020B0609010101010101" pitchFamily="49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0" y="0"/>
            <a:ext cx="3621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6742" y="956978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err="1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Rigth</a:t>
            </a:r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6729450" y="772312"/>
            <a:ext cx="972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ase 3 </a:t>
            </a:r>
            <a:r>
              <a:rPr kumimoji="1" lang="en-US" altLang="ja-JP" sz="1200" b="1" dirty="0" err="1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Rigth</a:t>
            </a:r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8385255" y="772312"/>
            <a:ext cx="972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ase 4  Left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077580" y="772312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ase 1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1820652" y="956978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Left</a:t>
            </a:r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3608977" y="956978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err="1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Rigth</a:t>
            </a:r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5072887" y="956978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Left</a:t>
            </a:r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 eye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4364682" y="772312"/>
            <a:ext cx="972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ase 2</a:t>
            </a:r>
            <a:endParaRPr kumimoji="1" lang="ja-JP" altLang="en-US" sz="12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267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1</Words>
  <Application>Microsoft Office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YUMI DELL</dc:creator>
  <cp:lastModifiedBy>owner</cp:lastModifiedBy>
  <cp:revision>5</cp:revision>
  <dcterms:created xsi:type="dcterms:W3CDTF">2014-06-25T21:43:52Z</dcterms:created>
  <dcterms:modified xsi:type="dcterms:W3CDTF">2014-10-21T14:31:26Z</dcterms:modified>
</cp:coreProperties>
</file>